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920038" cy="899953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9DACCE-9262-4951-89D7-C30D56F9620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44320" y="479160"/>
            <a:ext cx="6831000" cy="173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44320" y="2395440"/>
            <a:ext cx="683100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44320" y="5378400"/>
            <a:ext cx="683100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0457A1-82B9-46AD-A618-36C5BAB61A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44320" y="479160"/>
            <a:ext cx="6831000" cy="173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44320" y="2395440"/>
            <a:ext cx="333324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044600" y="2395440"/>
            <a:ext cx="333324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44320" y="5378400"/>
            <a:ext cx="333324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044600" y="5378400"/>
            <a:ext cx="333324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E384E6-269C-40B7-BB5C-81C33793BB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44320" y="479160"/>
            <a:ext cx="6831000" cy="173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44320" y="2395440"/>
            <a:ext cx="219924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854080" y="2395440"/>
            <a:ext cx="219924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163480" y="2395440"/>
            <a:ext cx="219924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44320" y="5378400"/>
            <a:ext cx="219924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854080" y="5378400"/>
            <a:ext cx="219924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163480" y="5378400"/>
            <a:ext cx="219924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BD7BED-1195-4893-BDD8-59FD182B248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44320" y="479160"/>
            <a:ext cx="6831000" cy="173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44320" y="2395440"/>
            <a:ext cx="6831000" cy="5710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862"/>
              </a:spcBef>
              <a:buNone/>
              <a:tabLst>
                <a:tab algn="l" pos="0"/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39230C-7118-4C8E-B797-482C7360FE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44320" y="479160"/>
            <a:ext cx="6831000" cy="173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44320" y="2395440"/>
            <a:ext cx="6831000" cy="571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87126B-FF24-4173-9457-A0DFCC7F25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44320" y="479160"/>
            <a:ext cx="6831000" cy="173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44320" y="2395440"/>
            <a:ext cx="3333240" cy="571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044600" y="2395440"/>
            <a:ext cx="3333240" cy="571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376FBD-ABA8-4CC5-AB26-65B429BEC9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44320" y="479160"/>
            <a:ext cx="6831000" cy="173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208DBC-6414-4185-9905-5A3BDC3507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44320" y="479160"/>
            <a:ext cx="6831000" cy="806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862"/>
              </a:spcBef>
              <a:tabLst>
                <a:tab algn="l" pos="0"/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42AA81-962F-48B1-AA6A-24552C0455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44320" y="479160"/>
            <a:ext cx="6831000" cy="173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44320" y="2395440"/>
            <a:ext cx="333324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044600" y="2395440"/>
            <a:ext cx="3333240" cy="571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44320" y="5378400"/>
            <a:ext cx="333324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9CAAFA-81D3-4B6C-9EA3-79D8D08114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44320" y="479160"/>
            <a:ext cx="6831000" cy="173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44320" y="2395440"/>
            <a:ext cx="3333240" cy="571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044600" y="2395440"/>
            <a:ext cx="333324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044600" y="5378400"/>
            <a:ext cx="333324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ACB700-012E-4B5A-B25B-CF483675A4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44320" y="479160"/>
            <a:ext cx="6831000" cy="173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44320" y="2395440"/>
            <a:ext cx="333324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044600" y="2395440"/>
            <a:ext cx="333324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44320" y="5378400"/>
            <a:ext cx="6831000" cy="272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62"/>
              </a:spcBef>
              <a:buNone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3AD88C-7861-43E1-82A0-3671BC8726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44320" y="479160"/>
            <a:ext cx="6831000" cy="173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44320" y="2395440"/>
            <a:ext cx="6831000" cy="571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96920" indent="-196920">
              <a:lnSpc>
                <a:spcPct val="90000"/>
              </a:lnSpc>
              <a:spcBef>
                <a:spcPts val="862"/>
              </a:spcBef>
              <a:buClr>
                <a:srgbClr val="000000"/>
              </a:buClr>
              <a:buFont typeface="Arial"/>
              <a:buChar char="•"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1" marL="593640" indent="-196920">
              <a:lnSpc>
                <a:spcPct val="90000"/>
              </a:lnSpc>
              <a:spcBef>
                <a:spcPts val="862"/>
              </a:spcBef>
              <a:buClr>
                <a:srgbClr val="000000"/>
              </a:buClr>
              <a:buFont typeface="Arial"/>
              <a:buChar char="•"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2" marL="988920" indent="-196920">
              <a:lnSpc>
                <a:spcPct val="90000"/>
              </a:lnSpc>
              <a:spcBef>
                <a:spcPts val="862"/>
              </a:spcBef>
              <a:buClr>
                <a:srgbClr val="000000"/>
              </a:buClr>
              <a:buFont typeface="Arial"/>
              <a:buChar char="•"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3" marL="1386000" indent="-196920">
              <a:lnSpc>
                <a:spcPct val="90000"/>
              </a:lnSpc>
              <a:spcBef>
                <a:spcPts val="862"/>
              </a:spcBef>
              <a:buClr>
                <a:srgbClr val="000000"/>
              </a:buClr>
              <a:buFont typeface="Arial"/>
              <a:buChar char="•"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4" marL="1781280" indent="-196920">
              <a:lnSpc>
                <a:spcPct val="90000"/>
              </a:lnSpc>
              <a:spcBef>
                <a:spcPts val="862"/>
              </a:spcBef>
              <a:buClr>
                <a:srgbClr val="000000"/>
              </a:buClr>
              <a:buFont typeface="Arial"/>
              <a:buChar char="•"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5" marL="1781280" indent="-196920">
              <a:lnSpc>
                <a:spcPct val="90000"/>
              </a:lnSpc>
              <a:spcBef>
                <a:spcPts val="862"/>
              </a:spcBef>
              <a:buClr>
                <a:srgbClr val="000000"/>
              </a:buClr>
              <a:buFont typeface="Arial"/>
              <a:buChar char="•"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6" marL="1781280" indent="-196920">
              <a:lnSpc>
                <a:spcPct val="90000"/>
              </a:lnSpc>
              <a:spcBef>
                <a:spcPts val="862"/>
              </a:spcBef>
              <a:buClr>
                <a:srgbClr val="000000"/>
              </a:buClr>
              <a:buFont typeface="Arial"/>
              <a:buChar char="•"/>
              <a:tabLst>
                <a:tab algn="l" pos="790560"/>
                <a:tab algn="l" pos="1581120"/>
                <a:tab algn="l" pos="2371680"/>
                <a:tab algn="l" pos="3162240"/>
                <a:tab algn="l" pos="3952800"/>
                <a:tab algn="l" pos="4743360"/>
                <a:tab algn="l" pos="5533920"/>
                <a:tab algn="l" pos="6324480"/>
                <a:tab algn="l" pos="7115040"/>
                <a:tab algn="l" pos="7905600"/>
                <a:tab algn="l" pos="8696160"/>
                <a:tab algn="l" pos="9487080"/>
                <a:tab algn="l" pos="102776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44680" y="8340480"/>
            <a:ext cx="1782720" cy="479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803160"/>
                <a:tab algn="l" pos="1606680"/>
                <a:tab algn="l" pos="2409840"/>
                <a:tab algn="l" pos="3213000"/>
                <a:tab algn="l" pos="4016520"/>
                <a:tab algn="l" pos="4819680"/>
                <a:tab algn="l" pos="5622840"/>
                <a:tab algn="l" pos="6426360"/>
                <a:tab algn="l" pos="7229520"/>
                <a:tab algn="l" pos="8032680"/>
                <a:tab algn="l" pos="8836200"/>
                <a:tab algn="l" pos="9639360"/>
                <a:tab algn="l" pos="10442520"/>
              </a:tabLst>
              <a:defRPr b="0" lang="zh-CN" sz="10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803160"/>
                <a:tab algn="l" pos="1606680"/>
                <a:tab algn="l" pos="2409840"/>
                <a:tab algn="l" pos="3213000"/>
                <a:tab algn="l" pos="4016520"/>
                <a:tab algn="l" pos="4819680"/>
                <a:tab algn="l" pos="5622840"/>
                <a:tab algn="l" pos="6426360"/>
                <a:tab algn="l" pos="7229520"/>
                <a:tab algn="l" pos="8032680"/>
                <a:tab algn="l" pos="8836200"/>
                <a:tab algn="l" pos="9639360"/>
                <a:tab algn="l" pos="10442520"/>
              </a:tabLst>
            </a:pPr>
            <a:r>
              <a:rPr b="0" lang="zh-CN" sz="10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624040" y="8340480"/>
            <a:ext cx="2671920" cy="479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803160"/>
                <a:tab algn="l" pos="1606680"/>
                <a:tab algn="l" pos="2409840"/>
                <a:tab algn="l" pos="3213000"/>
                <a:tab algn="l" pos="4016520"/>
                <a:tab algn="l" pos="4819680"/>
                <a:tab algn="l" pos="5622840"/>
                <a:tab algn="l" pos="6426360"/>
                <a:tab algn="l" pos="7229520"/>
                <a:tab algn="l" pos="8032680"/>
                <a:tab algn="l" pos="8836200"/>
                <a:tab algn="l" pos="9639360"/>
                <a:tab algn="l" pos="104425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592240" y="8340480"/>
            <a:ext cx="1783080" cy="479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803160"/>
                <a:tab algn="l" pos="1606680"/>
                <a:tab algn="l" pos="2409840"/>
                <a:tab algn="l" pos="3213000"/>
                <a:tab algn="l" pos="4016520"/>
                <a:tab algn="l" pos="4819680"/>
                <a:tab algn="l" pos="5622840"/>
                <a:tab algn="l" pos="6426360"/>
                <a:tab algn="l" pos="7229520"/>
                <a:tab algn="l" pos="8032680"/>
                <a:tab algn="l" pos="8836200"/>
                <a:tab algn="l" pos="9639360"/>
                <a:tab algn="l" pos="10442520"/>
              </a:tabLst>
              <a:defRPr b="0" lang="zh-CN" sz="10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803160"/>
                <a:tab algn="l" pos="1606680"/>
                <a:tab algn="l" pos="2409840"/>
                <a:tab algn="l" pos="3213000"/>
                <a:tab algn="l" pos="4016520"/>
                <a:tab algn="l" pos="4819680"/>
                <a:tab algn="l" pos="5622840"/>
                <a:tab algn="l" pos="6426360"/>
                <a:tab algn="l" pos="7229520"/>
                <a:tab algn="l" pos="8032680"/>
                <a:tab algn="l" pos="8836200"/>
                <a:tab algn="l" pos="9639360"/>
                <a:tab algn="l" pos="10442520"/>
              </a:tabLst>
            </a:pPr>
            <a:fld id="{49F7289A-1C03-42C6-B628-57DCEF940C12}" type="slidenum">
              <a:rPr b="0" lang="zh-CN" sz="10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33"/>
          <p:cNvSpPr/>
          <p:nvPr/>
        </p:nvSpPr>
        <p:spPr>
          <a:xfrm>
            <a:off x="1773360" y="1363680"/>
            <a:ext cx="1487520" cy="140004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1440" bIns="9144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inese database searching (n=1829): SinoMed (n = 586); CNKI (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</a:t>
            </a: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613); WanFang database (n=630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AutoShape 135"/>
          <p:cNvSpPr/>
          <p:nvPr/>
        </p:nvSpPr>
        <p:spPr>
          <a:xfrm rot="16200000">
            <a:off x="-67320" y="3710520"/>
            <a:ext cx="1695600" cy="297000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720" rIns="4572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creen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AutoShape 115"/>
          <p:cNvSpPr/>
          <p:nvPr/>
        </p:nvSpPr>
        <p:spPr>
          <a:xfrm rot="16200000">
            <a:off x="94320" y="7447680"/>
            <a:ext cx="1371600" cy="297000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720" rIns="4572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clude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AutoShape 134"/>
          <p:cNvSpPr/>
          <p:nvPr/>
        </p:nvSpPr>
        <p:spPr>
          <a:xfrm rot="16200000">
            <a:off x="94320" y="5648760"/>
            <a:ext cx="1371600" cy="297000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720" rIns="4572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ligibility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5" name=""/>
          <p:cNvGrpSpPr/>
          <p:nvPr/>
        </p:nvGrpSpPr>
        <p:grpSpPr>
          <a:xfrm>
            <a:off x="2758680" y="2768400"/>
            <a:ext cx="720" cy="360720"/>
            <a:chOff x="2758680" y="2768400"/>
            <a:chExt cx="720" cy="360720"/>
          </a:xfrm>
        </p:grpSpPr>
        <p:cxnSp>
          <p:nvCxnSpPr>
            <p:cNvPr id="46" name="AutoShape 132"/>
            <p:cNvCxnSpPr/>
            <p:nvPr/>
          </p:nvCxnSpPr>
          <p:spPr>
            <a:xfrm>
              <a:off x="2758680" y="2768400"/>
              <a:ext cx="1080" cy="36108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47" name=""/>
            <p:cNvSpPr txBox="1"/>
            <p:nvPr/>
          </p:nvSpPr>
          <p:spPr>
            <a:xfrm>
              <a:off x="2758680" y="2768400"/>
              <a:ext cx="360" cy="360360"/>
            </a:xfrm>
            <a:prstGeom prst="rect">
              <a:avLst/>
            </a:prstGeom>
            <a:noFill/>
            <a:ln w="0">
              <a:noFill/>
            </a:ln>
          </p:spPr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03160"/>
                  <a:tab algn="l" pos="1606680"/>
                  <a:tab algn="l" pos="2409840"/>
                  <a:tab algn="l" pos="3213000"/>
                  <a:tab algn="l" pos="4016520"/>
                  <a:tab algn="l" pos="4819680"/>
                  <a:tab algn="l" pos="5622840"/>
                  <a:tab algn="l" pos="6426360"/>
                  <a:tab algn="l" pos="7229520"/>
                  <a:tab algn="l" pos="8032680"/>
                  <a:tab algn="l" pos="8836200"/>
                  <a:tab algn="l" pos="9639360"/>
                  <a:tab algn="l" pos="10442520"/>
                </a:tabLst>
              </a:pP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8" name=""/>
          <p:cNvGrpSpPr/>
          <p:nvPr/>
        </p:nvGrpSpPr>
        <p:grpSpPr>
          <a:xfrm>
            <a:off x="5136840" y="2768400"/>
            <a:ext cx="720" cy="360720"/>
            <a:chOff x="5136840" y="2768400"/>
            <a:chExt cx="720" cy="360720"/>
          </a:xfrm>
        </p:grpSpPr>
        <p:cxnSp>
          <p:nvCxnSpPr>
            <p:cNvPr id="49" name="AutoShape 131"/>
            <p:cNvCxnSpPr/>
            <p:nvPr/>
          </p:nvCxnSpPr>
          <p:spPr>
            <a:xfrm>
              <a:off x="5136840" y="2768400"/>
              <a:ext cx="1080" cy="36108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50" name=""/>
            <p:cNvSpPr txBox="1"/>
            <p:nvPr/>
          </p:nvSpPr>
          <p:spPr>
            <a:xfrm>
              <a:off x="5136840" y="2768400"/>
              <a:ext cx="360" cy="360360"/>
            </a:xfrm>
            <a:prstGeom prst="rect">
              <a:avLst/>
            </a:prstGeom>
            <a:noFill/>
            <a:ln w="0">
              <a:noFill/>
            </a:ln>
          </p:spPr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03160"/>
                  <a:tab algn="l" pos="1606680"/>
                  <a:tab algn="l" pos="2409840"/>
                  <a:tab algn="l" pos="3213000"/>
                  <a:tab algn="l" pos="4016520"/>
                  <a:tab algn="l" pos="4819680"/>
                  <a:tab algn="l" pos="5622840"/>
                  <a:tab algn="l" pos="6426360"/>
                  <a:tab algn="l" pos="7229520"/>
                  <a:tab algn="l" pos="8032680"/>
                  <a:tab algn="l" pos="8836200"/>
                  <a:tab algn="l" pos="9639360"/>
                  <a:tab algn="l" pos="10442520"/>
                </a:tabLst>
              </a:pP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1" name="AutoShape 116"/>
          <p:cNvSpPr/>
          <p:nvPr/>
        </p:nvSpPr>
        <p:spPr>
          <a:xfrm rot="16200000">
            <a:off x="94320" y="1948320"/>
            <a:ext cx="1371600" cy="297000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720" rIns="4572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dentific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130"/>
          <p:cNvSpPr/>
          <p:nvPr/>
        </p:nvSpPr>
        <p:spPr>
          <a:xfrm>
            <a:off x="4765680" y="1363680"/>
            <a:ext cx="1208160" cy="1401840"/>
          </a:xfrm>
          <a:custGeom>
            <a:avLst/>
            <a:gdLst>
              <a:gd name="textAreaLeft" fmla="*/ 58680 w 1208160"/>
              <a:gd name="textAreaRight" fmla="*/ 1149480 w 1208160"/>
              <a:gd name="textAreaTop" fmla="*/ 58680 h 1401840"/>
              <a:gd name="textAreaBottom" fmla="*/ 1343160 h 1401840"/>
            </a:gdLst>
            <a:ahLst/>
            <a:rect l="textAreaLeft" t="textAreaTop" r="textAreaRight" b="textAreaBottom"/>
            <a:pathLst>
              <a:path w="21600" h="25062">
                <a:moveTo>
                  <a:pt x="3600" y="0"/>
                </a:moveTo>
                <a:arcTo wR="3600" hR="3600" stAng="16200000" swAng="-5400000"/>
                <a:lnTo>
                  <a:pt x="0" y="21462"/>
                </a:lnTo>
                <a:arcTo wR="3600" hR="3600" stAng="10800000" swAng="-5400000"/>
                <a:lnTo>
                  <a:pt x="18000" y="25062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solidFill>
            <a:srgbClr val="ffffff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1440" bIns="9144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records identified through manual retrieval</a:t>
            </a:r>
            <a:br>
              <a:rPr sz="1100"/>
            </a:b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n = 5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ctangle 129"/>
          <p:cNvSpPr/>
          <p:nvPr/>
        </p:nvSpPr>
        <p:spPr>
          <a:xfrm>
            <a:off x="2340000" y="3117960"/>
            <a:ext cx="3281400" cy="57132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1440" bIns="9144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cords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llected from 5 Chinese or English literature database</a:t>
            </a: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n = 5639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tangle 128"/>
          <p:cNvSpPr/>
          <p:nvPr/>
        </p:nvSpPr>
        <p:spPr>
          <a:xfrm>
            <a:off x="2797200" y="4173480"/>
            <a:ext cx="2311200" cy="35892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1440" bIns="9144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cords screened (n = 4154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ectangle 127"/>
          <p:cNvSpPr/>
          <p:nvPr/>
        </p:nvSpPr>
        <p:spPr>
          <a:xfrm>
            <a:off x="5580000" y="4492800"/>
            <a:ext cx="1882800" cy="75708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1440" bIns="9144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cords excluded</a:t>
            </a:r>
            <a:br>
              <a:rPr sz="1100"/>
            </a:b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rrelevant articles (n=3861); review articles (n=141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ctangle 126"/>
          <p:cNvSpPr/>
          <p:nvPr/>
        </p:nvSpPr>
        <p:spPr>
          <a:xfrm>
            <a:off x="2933640" y="5329080"/>
            <a:ext cx="2040120" cy="55728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1440" bIns="9144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ull-text articles assessed for eligibility (n =152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Rectangle 125"/>
          <p:cNvSpPr/>
          <p:nvPr/>
        </p:nvSpPr>
        <p:spPr>
          <a:xfrm>
            <a:off x="5573880" y="5767560"/>
            <a:ext cx="1888920" cy="76968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1440" bIns="9144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</a:t>
            </a: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udies of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yptococcosis or tuberculosis without co-infection </a:t>
            </a: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n = 45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124"/>
          <p:cNvSpPr/>
          <p:nvPr/>
        </p:nvSpPr>
        <p:spPr>
          <a:xfrm>
            <a:off x="4014720" y="7128000"/>
            <a:ext cx="2300400" cy="109512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1440" bIns="9144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udies of TB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/cryptococcosis co-infection in China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56 studies involving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97 cases</a:t>
            </a: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9" name=""/>
          <p:cNvGrpSpPr/>
          <p:nvPr/>
        </p:nvGrpSpPr>
        <p:grpSpPr>
          <a:xfrm>
            <a:off x="3952440" y="3703680"/>
            <a:ext cx="720" cy="457560"/>
            <a:chOff x="3952440" y="3703680"/>
            <a:chExt cx="720" cy="457560"/>
          </a:xfrm>
        </p:grpSpPr>
        <p:cxnSp>
          <p:nvCxnSpPr>
            <p:cNvPr id="60" name="AutoShape 122"/>
            <p:cNvCxnSpPr/>
            <p:nvPr/>
          </p:nvCxnSpPr>
          <p:spPr>
            <a:xfrm>
              <a:off x="3952440" y="3703680"/>
              <a:ext cx="1080" cy="45792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61" name=""/>
            <p:cNvSpPr txBox="1"/>
            <p:nvPr/>
          </p:nvSpPr>
          <p:spPr>
            <a:xfrm>
              <a:off x="3952440" y="3703680"/>
              <a:ext cx="360" cy="457200"/>
            </a:xfrm>
            <a:prstGeom prst="rect">
              <a:avLst/>
            </a:prstGeom>
            <a:noFill/>
            <a:ln w="0">
              <a:noFill/>
            </a:ln>
          </p:spPr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03160"/>
                  <a:tab algn="l" pos="1606680"/>
                  <a:tab algn="l" pos="2409840"/>
                  <a:tab algn="l" pos="3213000"/>
                  <a:tab algn="l" pos="4016520"/>
                  <a:tab algn="l" pos="4819680"/>
                  <a:tab algn="l" pos="5622840"/>
                  <a:tab algn="l" pos="6426360"/>
                  <a:tab algn="l" pos="7229520"/>
                  <a:tab algn="l" pos="8032680"/>
                  <a:tab algn="l" pos="8836200"/>
                  <a:tab algn="l" pos="9639360"/>
                  <a:tab algn="l" pos="10442520"/>
                </a:tabLst>
              </a:pP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2" name=""/>
          <p:cNvGrpSpPr/>
          <p:nvPr/>
        </p:nvGrpSpPr>
        <p:grpSpPr>
          <a:xfrm>
            <a:off x="3952440" y="4543200"/>
            <a:ext cx="720" cy="795600"/>
            <a:chOff x="3952440" y="4543200"/>
            <a:chExt cx="720" cy="795600"/>
          </a:xfrm>
        </p:grpSpPr>
        <p:cxnSp>
          <p:nvCxnSpPr>
            <p:cNvPr id="63" name="AutoShape 121"/>
            <p:cNvCxnSpPr/>
            <p:nvPr/>
          </p:nvCxnSpPr>
          <p:spPr>
            <a:xfrm>
              <a:off x="3952440" y="4543200"/>
              <a:ext cx="1080" cy="79596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64" name=""/>
            <p:cNvSpPr txBox="1"/>
            <p:nvPr/>
          </p:nvSpPr>
          <p:spPr>
            <a:xfrm>
              <a:off x="3952440" y="4543200"/>
              <a:ext cx="360" cy="795240"/>
            </a:xfrm>
            <a:prstGeom prst="rect">
              <a:avLst/>
            </a:prstGeom>
            <a:noFill/>
            <a:ln w="0">
              <a:noFill/>
            </a:ln>
          </p:spPr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03160"/>
                  <a:tab algn="l" pos="1606680"/>
                  <a:tab algn="l" pos="2409840"/>
                  <a:tab algn="l" pos="3213000"/>
                  <a:tab algn="l" pos="4016520"/>
                  <a:tab algn="l" pos="4819680"/>
                  <a:tab algn="l" pos="5622840"/>
                  <a:tab algn="l" pos="6426360"/>
                  <a:tab algn="l" pos="7229520"/>
                  <a:tab algn="l" pos="8032680"/>
                  <a:tab algn="l" pos="8836200"/>
                  <a:tab algn="l" pos="9639360"/>
                  <a:tab algn="l" pos="10442520"/>
                </a:tabLst>
              </a:pP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5" name=""/>
          <p:cNvGrpSpPr/>
          <p:nvPr/>
        </p:nvGrpSpPr>
        <p:grpSpPr>
          <a:xfrm>
            <a:off x="3952800" y="4887720"/>
            <a:ext cx="1602360" cy="720"/>
            <a:chOff x="3952800" y="4887720"/>
            <a:chExt cx="1602360" cy="720"/>
          </a:xfrm>
        </p:grpSpPr>
        <p:cxnSp>
          <p:nvCxnSpPr>
            <p:cNvPr id="66" name="AutoShape 118"/>
            <p:cNvCxnSpPr/>
            <p:nvPr/>
          </p:nvCxnSpPr>
          <p:spPr>
            <a:xfrm>
              <a:off x="3952800" y="4887720"/>
              <a:ext cx="1602720" cy="108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67" name=""/>
            <p:cNvSpPr txBox="1"/>
            <p:nvPr/>
          </p:nvSpPr>
          <p:spPr>
            <a:xfrm>
              <a:off x="3952800" y="4887720"/>
              <a:ext cx="1602000" cy="360"/>
            </a:xfrm>
            <a:prstGeom prst="rect">
              <a:avLst/>
            </a:prstGeom>
            <a:noFill/>
            <a:ln w="0">
              <a:noFill/>
            </a:ln>
          </p:spPr>
          <p:txBody>
            <a:bodyPr lIns="90000" rIns="90000" tIns="-46440" bIns="-4644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03160"/>
                  <a:tab algn="l" pos="1606680"/>
                  <a:tab algn="l" pos="2409840"/>
                  <a:tab algn="l" pos="3213000"/>
                  <a:tab algn="l" pos="4016520"/>
                  <a:tab algn="l" pos="4819680"/>
                  <a:tab algn="l" pos="5622840"/>
                  <a:tab algn="l" pos="6426360"/>
                  <a:tab algn="l" pos="7229520"/>
                  <a:tab algn="l" pos="8032680"/>
                  <a:tab algn="l" pos="8836200"/>
                  <a:tab algn="l" pos="9639360"/>
                  <a:tab algn="l" pos="10442520"/>
                </a:tabLst>
              </a:pP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8" name=""/>
          <p:cNvGrpSpPr/>
          <p:nvPr/>
        </p:nvGrpSpPr>
        <p:grpSpPr>
          <a:xfrm>
            <a:off x="3952800" y="6160680"/>
            <a:ext cx="1602360" cy="720"/>
            <a:chOff x="3952800" y="6160680"/>
            <a:chExt cx="1602360" cy="720"/>
          </a:xfrm>
        </p:grpSpPr>
        <p:cxnSp>
          <p:nvCxnSpPr>
            <p:cNvPr id="69" name="AutoShape 117"/>
            <p:cNvCxnSpPr/>
            <p:nvPr/>
          </p:nvCxnSpPr>
          <p:spPr>
            <a:xfrm>
              <a:off x="3952800" y="6160680"/>
              <a:ext cx="1602720" cy="108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70" name=""/>
            <p:cNvSpPr txBox="1"/>
            <p:nvPr/>
          </p:nvSpPr>
          <p:spPr>
            <a:xfrm>
              <a:off x="3952800" y="6160680"/>
              <a:ext cx="1602000" cy="360"/>
            </a:xfrm>
            <a:prstGeom prst="rect">
              <a:avLst/>
            </a:prstGeom>
            <a:noFill/>
            <a:ln w="0">
              <a:noFill/>
            </a:ln>
          </p:spPr>
          <p:txBody>
            <a:bodyPr lIns="90000" rIns="90000" tIns="-46440" bIns="-4644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03160"/>
                  <a:tab algn="l" pos="1606680"/>
                  <a:tab algn="l" pos="2409840"/>
                  <a:tab algn="l" pos="3213000"/>
                  <a:tab algn="l" pos="4016520"/>
                  <a:tab algn="l" pos="4819680"/>
                  <a:tab algn="l" pos="5622840"/>
                  <a:tab algn="l" pos="6426360"/>
                  <a:tab algn="l" pos="7229520"/>
                  <a:tab algn="l" pos="8032680"/>
                  <a:tab algn="l" pos="8836200"/>
                  <a:tab algn="l" pos="9639360"/>
                  <a:tab algn="l" pos="10442520"/>
                </a:tabLst>
              </a:pP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71" name="Picture 136" descr="Consort-Logo-Graphic-30-12-071"/>
          <p:cNvPicPr/>
          <p:nvPr/>
        </p:nvPicPr>
        <p:blipFill>
          <a:blip r:embed="rId1"/>
          <a:srcRect l="3000" t="20691" r="87103" b="17237"/>
          <a:stretch/>
        </p:blipFill>
        <p:spPr>
          <a:xfrm>
            <a:off x="517680" y="338040"/>
            <a:ext cx="685800" cy="62388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sp>
        <p:nvSpPr>
          <p:cNvPr id="72" name="Rectangle 138"/>
          <p:cNvSpPr/>
          <p:nvPr/>
        </p:nvSpPr>
        <p:spPr>
          <a:xfrm>
            <a:off x="1712880" y="337320"/>
            <a:ext cx="29718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ctr" pos="2743200"/>
                <a:tab algn="r" pos="5486400"/>
                <a:tab algn="r" pos="8801280"/>
                <a:tab algn="l" pos="9144000"/>
                <a:tab algn="l" pos="10058400"/>
              </a:tabLst>
            </a:pPr>
            <a:r>
              <a:rPr b="1" lang="en-CA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ISMA 2009 Flow Diagram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ctr" pos="2743200"/>
                <a:tab algn="r" pos="5486400"/>
                <a:tab algn="r" pos="880128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Rectangle 133"/>
          <p:cNvSpPr/>
          <p:nvPr/>
        </p:nvSpPr>
        <p:spPr>
          <a:xfrm>
            <a:off x="3327480" y="1363680"/>
            <a:ext cx="1363680" cy="1409760"/>
          </a:xfrm>
          <a:custGeom>
            <a:avLst/>
            <a:gdLst>
              <a:gd name="textAreaLeft" fmla="*/ 66240 w 1363680"/>
              <a:gd name="textAreaRight" fmla="*/ 1297440 w 1363680"/>
              <a:gd name="textAreaTop" fmla="*/ 66240 h 1409760"/>
              <a:gd name="textAreaBottom" fmla="*/ 1343520 h 1409760"/>
            </a:gdLst>
            <a:ahLst/>
            <a:rect l="textAreaLeft" t="textAreaTop" r="textAreaRight" b="textAreaBottom"/>
            <a:pathLst>
              <a:path w="21600" h="22330">
                <a:moveTo>
                  <a:pt x="3600" y="0"/>
                </a:moveTo>
                <a:arcTo wR="3600" hR="3600" stAng="16200000" swAng="-5400000"/>
                <a:lnTo>
                  <a:pt x="0" y="18730"/>
                </a:lnTo>
                <a:arcTo wR="3600" hR="3600" stAng="10800000" swAng="-5400000"/>
                <a:lnTo>
                  <a:pt x="18000" y="22330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solidFill>
            <a:srgbClr val="ffffff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1440" bIns="9144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ternational database searching (n=3805): Pubmed (n = 1159); Embase (n = 2646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4" name=""/>
          <p:cNvGrpSpPr/>
          <p:nvPr/>
        </p:nvGrpSpPr>
        <p:grpSpPr>
          <a:xfrm>
            <a:off x="4011120" y="2768400"/>
            <a:ext cx="720" cy="360720"/>
            <a:chOff x="4011120" y="2768400"/>
            <a:chExt cx="720" cy="360720"/>
          </a:xfrm>
        </p:grpSpPr>
        <p:cxnSp>
          <p:nvCxnSpPr>
            <p:cNvPr id="75" name="AutoShape 131"/>
            <p:cNvCxnSpPr/>
            <p:nvPr/>
          </p:nvCxnSpPr>
          <p:spPr>
            <a:xfrm>
              <a:off x="4011120" y="2768400"/>
              <a:ext cx="1080" cy="36108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76" name=""/>
            <p:cNvSpPr txBox="1"/>
            <p:nvPr/>
          </p:nvSpPr>
          <p:spPr>
            <a:xfrm>
              <a:off x="4011120" y="2768400"/>
              <a:ext cx="360" cy="360360"/>
            </a:xfrm>
            <a:prstGeom prst="rect">
              <a:avLst/>
            </a:prstGeom>
            <a:noFill/>
            <a:ln w="0">
              <a:noFill/>
            </a:ln>
          </p:spPr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03160"/>
                  <a:tab algn="l" pos="1606680"/>
                  <a:tab algn="l" pos="2409840"/>
                  <a:tab algn="l" pos="3213000"/>
                  <a:tab algn="l" pos="4016520"/>
                  <a:tab algn="l" pos="4819680"/>
                  <a:tab algn="l" pos="5622840"/>
                  <a:tab algn="l" pos="6426360"/>
                  <a:tab algn="l" pos="7229520"/>
                  <a:tab algn="l" pos="8032680"/>
                  <a:tab algn="l" pos="8836200"/>
                  <a:tab algn="l" pos="9639360"/>
                  <a:tab algn="l" pos="10442520"/>
                </a:tabLst>
              </a:pP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7" name="Rectangle 127"/>
          <p:cNvSpPr/>
          <p:nvPr/>
        </p:nvSpPr>
        <p:spPr>
          <a:xfrm>
            <a:off x="5575320" y="3767040"/>
            <a:ext cx="1887480" cy="33192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1440" bIns="9144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uplicates excluded (n=1485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8" name=""/>
          <p:cNvGrpSpPr/>
          <p:nvPr/>
        </p:nvGrpSpPr>
        <p:grpSpPr>
          <a:xfrm>
            <a:off x="3960720" y="3927240"/>
            <a:ext cx="1602360" cy="720"/>
            <a:chOff x="3960720" y="3927240"/>
            <a:chExt cx="1602360" cy="720"/>
          </a:xfrm>
        </p:grpSpPr>
        <p:cxnSp>
          <p:nvCxnSpPr>
            <p:cNvPr id="79" name="AutoShape 118"/>
            <p:cNvCxnSpPr/>
            <p:nvPr/>
          </p:nvCxnSpPr>
          <p:spPr>
            <a:xfrm>
              <a:off x="3960720" y="3927240"/>
              <a:ext cx="1602720" cy="108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80" name=""/>
            <p:cNvSpPr txBox="1"/>
            <p:nvPr/>
          </p:nvSpPr>
          <p:spPr>
            <a:xfrm>
              <a:off x="3960720" y="3927240"/>
              <a:ext cx="1602000" cy="360"/>
            </a:xfrm>
            <a:prstGeom prst="rect">
              <a:avLst/>
            </a:prstGeom>
            <a:noFill/>
            <a:ln w="0">
              <a:noFill/>
            </a:ln>
          </p:spPr>
          <p:txBody>
            <a:bodyPr lIns="90000" rIns="90000" tIns="-46440" bIns="-4644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03160"/>
                  <a:tab algn="l" pos="1606680"/>
                  <a:tab algn="l" pos="2409840"/>
                  <a:tab algn="l" pos="3213000"/>
                  <a:tab algn="l" pos="4016520"/>
                  <a:tab algn="l" pos="4819680"/>
                  <a:tab algn="l" pos="5622840"/>
                  <a:tab algn="l" pos="6426360"/>
                  <a:tab algn="l" pos="7229520"/>
                  <a:tab algn="l" pos="8032680"/>
                  <a:tab algn="l" pos="8836200"/>
                  <a:tab algn="l" pos="9639360"/>
                  <a:tab algn="l" pos="10442520"/>
                </a:tabLst>
              </a:pP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1" name="Rectangle 124"/>
          <p:cNvSpPr/>
          <p:nvPr/>
        </p:nvSpPr>
        <p:spPr>
          <a:xfrm>
            <a:off x="1608120" y="7128000"/>
            <a:ext cx="2300400" cy="111276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1440" bIns="9144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udies of TB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/cryptococcosis co-infection outside of China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51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udies involving 116 cases</a:t>
            </a:r>
            <a:r>
              <a:rPr b="0" lang="en-CA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2" name="肘形连接符 3"/>
          <p:cNvCxnSpPr>
            <a:stCxn id="56" idx="2"/>
            <a:endCxn id="81" idx="0"/>
          </p:cNvCxnSpPr>
          <p:nvPr/>
        </p:nvCxnSpPr>
        <p:spPr>
          <a:xfrm rot="5400000">
            <a:off x="2734920" y="5909400"/>
            <a:ext cx="1242000" cy="1195560"/>
          </a:xfrm>
          <a:prstGeom prst="bentConnector3">
            <a:avLst>
              <a:gd name="adj1" fmla="val 50014"/>
            </a:avLst>
          </a:prstGeom>
          <a:ln w="28440">
            <a:solidFill>
              <a:srgbClr val="000000"/>
            </a:solidFill>
            <a:round/>
            <a:tailEnd len="med" type="triangle" w="med"/>
          </a:ln>
        </p:spPr>
      </p:cxnSp>
      <p:cxnSp>
        <p:nvCxnSpPr>
          <p:cNvPr id="83" name="肘形连接符 30"/>
          <p:cNvCxnSpPr>
            <a:stCxn id="56" idx="2"/>
            <a:endCxn id="58" idx="0"/>
          </p:cNvCxnSpPr>
          <p:nvPr/>
        </p:nvCxnSpPr>
        <p:spPr>
          <a:xfrm flipH="1" rot="16200000">
            <a:off x="3938400" y="5901120"/>
            <a:ext cx="1242000" cy="1211760"/>
          </a:xfrm>
          <a:prstGeom prst="bentConnector3">
            <a:avLst>
              <a:gd name="adj1" fmla="val 50014"/>
            </a:avLst>
          </a:prstGeom>
          <a:ln w="28440">
            <a:solidFill>
              <a:srgbClr val="000000"/>
            </a:solidFill>
            <a:round/>
            <a:tailEnd len="med" type="triangle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5-04T02:55:26Z</dcterms:created>
  <dc:creator>方文捷</dc:creator>
  <dc:description/>
  <dc:language>en-US</dc:language>
  <cp:lastModifiedBy>vidya.p</cp:lastModifiedBy>
  <dcterms:modified xsi:type="dcterms:W3CDTF">2017-08-22T10:24:03Z</dcterms:modified>
  <cp:revision>97</cp:revision>
  <dc:subject/>
  <dc:title>PowerPoint 演示文稿</dc:title>
</cp:coreProperties>
</file>